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3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hakal, Kshitiz" userId="6ff78c19-3d13-44c6-91c3-34d44c8b7c49" providerId="ADAL" clId="{44290A6D-1245-4387-A82D-206BE90B6C6B}"/>
    <pc:docChg chg="delSld modSld">
      <pc:chgData name="Dhakal, Kshitiz" userId="6ff78c19-3d13-44c6-91c3-34d44c8b7c49" providerId="ADAL" clId="{44290A6D-1245-4387-A82D-206BE90B6C6B}" dt="2022-12-17T21:09:21.760" v="4" actId="20577"/>
      <pc:docMkLst>
        <pc:docMk/>
      </pc:docMkLst>
      <pc:sldChg chg="modSp">
        <pc:chgData name="Dhakal, Kshitiz" userId="6ff78c19-3d13-44c6-91c3-34d44c8b7c49" providerId="ADAL" clId="{44290A6D-1245-4387-A82D-206BE90B6C6B}" dt="2022-12-17T21:09:21.760" v="4" actId="20577"/>
        <pc:sldMkLst>
          <pc:docMk/>
          <pc:sldMk cId="3477961926" sldId="259"/>
        </pc:sldMkLst>
        <pc:spChg chg="mod">
          <ac:chgData name="Dhakal, Kshitiz" userId="6ff78c19-3d13-44c6-91c3-34d44c8b7c49" providerId="ADAL" clId="{44290A6D-1245-4387-A82D-206BE90B6C6B}" dt="2022-12-17T21:09:21.760" v="4" actId="20577"/>
          <ac:spMkLst>
            <pc:docMk/>
            <pc:sldMk cId="3477961926" sldId="259"/>
            <ac:spMk id="16" creationId="{2B690EF7-7BD5-4712-A64E-05B749AC46AE}"/>
          </ac:spMkLst>
        </pc:spChg>
      </pc:sldChg>
    </pc:docChg>
  </pc:docChgLst>
  <pc:docChgLst>
    <pc:chgData name="Dhakal, Kshitiz" userId="6ff78c19-3d13-44c6-91c3-34d44c8b7c49" providerId="ADAL" clId="{4117345A-3E98-4165-934D-62D4EB670CB4}"/>
    <pc:docChg chg="modSld">
      <pc:chgData name="Dhakal, Kshitiz" userId="6ff78c19-3d13-44c6-91c3-34d44c8b7c49" providerId="ADAL" clId="{4117345A-3E98-4165-934D-62D4EB670CB4}" dt="2023-01-05T15:09:32.363" v="1"/>
      <pc:docMkLst>
        <pc:docMk/>
      </pc:docMkLst>
      <pc:sldChg chg="addSp delSp">
        <pc:chgData name="Dhakal, Kshitiz" userId="6ff78c19-3d13-44c6-91c3-34d44c8b7c49" providerId="ADAL" clId="{4117345A-3E98-4165-934D-62D4EB670CB4}" dt="2023-01-05T15:09:32.363" v="1"/>
        <pc:sldMkLst>
          <pc:docMk/>
          <pc:sldMk cId="3477961926" sldId="259"/>
        </pc:sldMkLst>
        <pc:graphicFrameChg chg="del">
          <ac:chgData name="Dhakal, Kshitiz" userId="6ff78c19-3d13-44c6-91c3-34d44c8b7c49" providerId="ADAL" clId="{4117345A-3E98-4165-934D-62D4EB670CB4}" dt="2023-01-05T15:08:58.126" v="0" actId="478"/>
          <ac:graphicFrameMkLst>
            <pc:docMk/>
            <pc:sldMk cId="3477961926" sldId="259"/>
            <ac:graphicFrameMk id="6" creationId="{8A1D6A56-0912-477E-8B45-5199B5B38443}"/>
          </ac:graphicFrameMkLst>
        </pc:graphicFrameChg>
        <pc:picChg chg="add">
          <ac:chgData name="Dhakal, Kshitiz" userId="6ff78c19-3d13-44c6-91c3-34d44c8b7c49" providerId="ADAL" clId="{4117345A-3E98-4165-934D-62D4EB670CB4}" dt="2023-01-05T15:09:32.363" v="1"/>
          <ac:picMkLst>
            <pc:docMk/>
            <pc:sldMk cId="3477961926" sldId="259"/>
            <ac:picMk id="1026" creationId="{CC58D678-E630-4817-89A0-3632A37343D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278D6B-F7ED-41F8-B568-F5BD92AA11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D115E42-382A-4928-AE8E-83A25EC563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FF4248-1990-42B4-9220-5B304816F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2E38C6-E70D-48D3-B831-71D977939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EEDC40-C511-4CCE-A562-4F7031226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068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AEB19F-E554-4F12-B51C-85AA96E0E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4F06CB-B22B-454E-86FA-7785077D31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BF364B-DEAC-4C7F-8EDC-E4C8E28C4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E117AF-FD6F-483F-97D8-088806AF0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D0C1B5-E392-4F13-A752-23A7E928B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377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84E937-1DB2-43C6-B98F-C9ABF74915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E8D816-C462-44CE-9D32-1DE88BBE9E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8B569B-B31B-4EBE-ADD5-BB1268BEC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B6E20C-432D-4098-82CC-904392511A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BF85DD-E2DE-4B59-952B-7F5D5FD17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033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1F4A88-EC65-45F7-9458-33A1BF14C9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299D30-BA95-4A68-9E24-0FFD7836E2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7917E8-9C58-4BEC-8793-98EB659F2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1D7E5-A8DB-4421-A843-B512C2F8E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319EB1-4147-4AFC-8817-4F63D4C05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56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2D04B6-907A-4738-9159-10CC1E3ACB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85C46D-2D7B-4F8A-AB9E-1628075E6C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8E47A0-8352-471A-9F99-CCC45688D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AB8437-73A4-4D64-93B6-8AA293F52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92FB5E-25F1-4B36-9397-D61EECEEC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736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E5E3CE-2815-4638-ACDD-5797E9B853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FAB132-A054-42FD-B3F9-1700745080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BC9098-F25E-496C-834C-077F3F3734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B12D2B-F9E1-4182-9838-C207DFBD9B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179645-5FCB-4319-A325-3B8B00153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5BEEAC-644B-4BBC-BC88-80BE470B9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44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BE2F58-07DA-43D4-AEE8-2DD07FC9C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A6D503-A8DE-4A71-8E02-564863FB24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11E57E-95A9-4F89-8AF0-113F5E9D29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1FA732-3D17-4DB9-B5C6-536B1B4836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8A5F03D-DED9-43E8-9E60-63D70C948E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865F6B-7AE7-4D46-9883-124FA35F0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6F21C9-EC26-4668-82A4-0D4E9A1B0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7F68CE-2398-46AB-9768-6972F926C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405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10E3D9-081B-4899-BFCF-30D7FCABFB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9CE9A58-5443-44A9-9237-AA17E7E1D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9E1BF68-F8BB-47D4-B592-167DB6760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6C1C99-B6BE-47D4-9858-98099116B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001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DC1543-7475-4C83-896F-C88D1E4A7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1C592D-DF04-47D2-9342-7BC79BFB8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431F42A-146D-4794-A8B5-7595372B24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082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CF63FE-4ECB-4A93-9F7A-9D7044D52F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32F690-310A-4807-8DB1-1B2890CB2B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36ABE3-ABA3-4621-B897-9AD1FDBF06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775D07-F2F2-4433-BA0C-BBF05ACF3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D57979-F27D-4F32-A77A-F9118312A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4E0748-C6BD-4E3E-931B-7BEC9DB8C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687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D395F-6C98-45D3-A257-5DE643E28E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EEDA789-D234-4C9C-BB5D-9965BB30CA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98338E-8A82-4A52-9F77-495BD5732A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3D5E42-C9B3-4FA1-9B57-1C2D09929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9EF57E-92A2-4D82-B9A3-60C17999A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F56AED-0FD0-4A7A-AECD-62C50C37A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277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29F54F-D9C9-4706-8512-F2C148A11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2FB107-9F2D-4633-A666-338CA090F7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27A935-0362-4120-96D0-5F67FEC1FE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A34D0A-53BC-4501-B255-D796756A228B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140E7E-1329-4FCB-9083-4C8222920F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B24EF3-D6AF-451E-A0F7-61A7D37C51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A9A2E4-DC6C-499C-A5A2-A10671BEEB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770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CC58D678-E630-4817-89A0-3632A37343D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608138"/>
            <a:ext cx="12192000" cy="3641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E2D492E-9711-D4B6-D43C-9CC08A4C792C}"/>
              </a:ext>
            </a:extLst>
          </p:cNvPr>
          <p:cNvSpPr txBox="1"/>
          <p:nvPr/>
        </p:nvSpPr>
        <p:spPr>
          <a:xfrm>
            <a:off x="0" y="5657671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igure S6: Classified image of severely infected samples, where most of the kernel pixels are in-</a:t>
            </a:r>
            <a:r>
              <a:rPr lang="en-US" dirty="0" err="1"/>
              <a:t>fected</a:t>
            </a:r>
            <a:r>
              <a:rPr lang="en-US" dirty="0"/>
              <a:t> (as shown in purple color) and a fraction are non-symptomatic (as shown in green color)</a:t>
            </a:r>
          </a:p>
        </p:txBody>
      </p:sp>
    </p:spTree>
    <p:extLst>
      <p:ext uri="{BB962C8B-B14F-4D97-AF65-F5344CB8AC3E}">
        <p14:creationId xmlns:p14="http://schemas.microsoft.com/office/powerpoint/2010/main" val="3477961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8C0679CE3F1146B99428810CFFD1A5" ma:contentTypeVersion="13" ma:contentTypeDescription="Create a new document." ma:contentTypeScope="" ma:versionID="87104e6739588b1d33bffce79ec9ef76">
  <xsd:schema xmlns:xsd="http://www.w3.org/2001/XMLSchema" xmlns:xs="http://www.w3.org/2001/XMLSchema" xmlns:p="http://schemas.microsoft.com/office/2006/metadata/properties" xmlns:ns3="9435e4ad-f246-4104-a637-66c8bc3c99a7" xmlns:ns4="64ecab17-5948-449f-a717-624ba6338b70" targetNamespace="http://schemas.microsoft.com/office/2006/metadata/properties" ma:root="true" ma:fieldsID="0405a160c580c868c8adfe7b1b3dd395" ns3:_="" ns4:_="">
    <xsd:import namespace="9435e4ad-f246-4104-a637-66c8bc3c99a7"/>
    <xsd:import namespace="64ecab17-5948-449f-a717-624ba6338b7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435e4ad-f246-4104-a637-66c8bc3c99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4ecab17-5948-449f-a717-624ba6338b70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C4ABD27-7DD0-4F3E-B1A6-5C63CB4E8791}">
  <ds:schemaRefs>
    <ds:schemaRef ds:uri="http://schemas.openxmlformats.org/package/2006/metadata/core-properties"/>
    <ds:schemaRef ds:uri="http://www.w3.org/XML/1998/namespace"/>
    <ds:schemaRef ds:uri="http://schemas.microsoft.com/office/2006/metadata/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purl.org/dc/terms/"/>
    <ds:schemaRef ds:uri="http://purl.org/dc/dcmitype/"/>
    <ds:schemaRef ds:uri="64ecab17-5948-449f-a717-624ba6338b70"/>
    <ds:schemaRef ds:uri="9435e4ad-f246-4104-a637-66c8bc3c99a7"/>
  </ds:schemaRefs>
</ds:datastoreItem>
</file>

<file path=customXml/itemProps2.xml><?xml version="1.0" encoding="utf-8"?>
<ds:datastoreItem xmlns:ds="http://schemas.openxmlformats.org/officeDocument/2006/customXml" ds:itemID="{A1B0A893-EF04-407C-9FDF-59B93DE9D61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435e4ad-f246-4104-a637-66c8bc3c99a7"/>
    <ds:schemaRef ds:uri="64ecab17-5948-449f-a717-624ba6338b7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FD758914-2C6B-4568-A817-E67B145258A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3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Kshitiz</dc:creator>
  <cp:lastModifiedBy>song li</cp:lastModifiedBy>
  <cp:revision>12</cp:revision>
  <dcterms:created xsi:type="dcterms:W3CDTF">2022-08-01T14:47:24Z</dcterms:created>
  <dcterms:modified xsi:type="dcterms:W3CDTF">2023-03-28T00:20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8C0679CE3F1146B99428810CFFD1A5</vt:lpwstr>
  </property>
</Properties>
</file>